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32"/>
  </p:normalViewPr>
  <p:slideViewPr>
    <p:cSldViewPr snapToGrid="0" snapToObjects="1">
      <p:cViewPr varScale="1">
        <p:scale>
          <a:sx n="106" d="100"/>
          <a:sy n="106" d="100"/>
        </p:scale>
        <p:origin x="79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9FCB403-346D-1B4A-A060-2D855A2C5DC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C456D33C-EE43-4E44-B16D-BFDA4976B3C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080991A-473A-EB49-8CE6-4297BCA7BB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D4A3EB-807B-AC4C-BE36-2610353B9930}" type="datetimeFigureOut">
              <a:rPr kumimoji="1" lang="zh-CN" altLang="en-US" smtClean="0"/>
              <a:t>2020/1/16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8A859A8-F72E-7C4B-B985-ADA394ABBD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7ED70FC-CBA9-D542-8109-7F0E616B75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AE91D3-742C-E048-8192-979A678C7DB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7928334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9676DF4-28F3-414C-BF26-02B29DF684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D83F04A-CE3B-7041-8BD0-76647C27501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85CE297-1F83-9E42-8DCB-2058B2900D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D4A3EB-807B-AC4C-BE36-2610353B9930}" type="datetimeFigureOut">
              <a:rPr kumimoji="1" lang="zh-CN" altLang="en-US" smtClean="0"/>
              <a:t>2020/1/16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8DE8F8C-90B7-674B-85D0-EF3C154B53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F8A0234-C450-9A40-8DC6-4D4B767AF2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AE91D3-742C-E048-8192-979A678C7DB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3953719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CE08D109-0770-1F4C-8ECA-3BBD71F8E4B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0DA2C50-990B-9141-9336-E066B025143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814654A-CC58-764C-89C6-C8D28143E4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D4A3EB-807B-AC4C-BE36-2610353B9930}" type="datetimeFigureOut">
              <a:rPr kumimoji="1" lang="zh-CN" altLang="en-US" smtClean="0"/>
              <a:t>2020/1/16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5751D08-0D54-8E40-ABDB-152825E809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134C08A-AD4C-944E-A89A-7C26AD5759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AE91D3-742C-E048-8192-979A678C7DB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8009227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1AD5522-7F92-B948-BE32-00BA7DBC9B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1660514-31FE-D449-B782-FBA1AFB47C2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708685E-B351-9246-9DFA-224D139DAF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D4A3EB-807B-AC4C-BE36-2610353B9930}" type="datetimeFigureOut">
              <a:rPr kumimoji="1" lang="zh-CN" altLang="en-US" smtClean="0"/>
              <a:t>2020/1/16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C0AF5A9-3426-5447-8F93-BBFD097767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1985DAC-3D6A-5545-BED4-5B6CC4A4A4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AE91D3-742C-E048-8192-979A678C7DB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7498023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A409174-2DDF-6B4A-8F53-FF406640F2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4EFA3AD-6D95-C943-8C4F-52CAF85127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45CC351-AC09-6842-B53B-695B2959F0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D4A3EB-807B-AC4C-BE36-2610353B9930}" type="datetimeFigureOut">
              <a:rPr kumimoji="1" lang="zh-CN" altLang="en-US" smtClean="0"/>
              <a:t>2020/1/16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8F2C615-DF88-EC4C-A5AA-386ED76052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A419375-EE7C-9748-9059-F1F60A9CB1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AE91D3-742C-E048-8192-979A678C7DB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1945853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D311823-6915-EC49-9586-ACFA0CC956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3D7C287-3953-3B49-BF49-0B0F2EBEF1B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D894DF6-6496-3649-9A7E-B10FD8BDF79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A18F603-5CC6-0F48-A850-D244BAF1D9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D4A3EB-807B-AC4C-BE36-2610353B9930}" type="datetimeFigureOut">
              <a:rPr kumimoji="1" lang="zh-CN" altLang="en-US" smtClean="0"/>
              <a:t>2020/1/16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7E4BE13-978B-314A-B09B-80FA9545CE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AB94875-D86A-D347-96E8-B2447705BE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AE91D3-742C-E048-8192-979A678C7DB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9556230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FF26422-B9AF-7940-AD01-5B09CD41B5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81047B7-2203-3949-B095-9111D1BCD4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035131B-436A-B542-9D47-1E24EB004FB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1A8863E3-AF36-AC47-AFE4-5501BFBD4EC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FDA9A9C5-777C-2747-8FD2-CE1913D134F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1F646E69-F348-EC45-8F46-5C3BF5E777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D4A3EB-807B-AC4C-BE36-2610353B9930}" type="datetimeFigureOut">
              <a:rPr kumimoji="1" lang="zh-CN" altLang="en-US" smtClean="0"/>
              <a:t>2020/1/16</a:t>
            </a:fld>
            <a:endParaRPr kumimoji="1"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A9F04D6-F593-7B40-B18E-A98EA1372F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703A7E7D-001C-1642-8AAE-2AEB8CA7C4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AE91D3-742C-E048-8192-979A678C7DB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814512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44AECED-E90F-CC45-9668-07F5CC4F1B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A7199A5E-417A-5740-AED6-56635E9C02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D4A3EB-807B-AC4C-BE36-2610353B9930}" type="datetimeFigureOut">
              <a:rPr kumimoji="1" lang="zh-CN" altLang="en-US" smtClean="0"/>
              <a:t>2020/1/16</a:t>
            </a:fld>
            <a:endParaRPr kumimoji="1"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EA8EF1E3-B7A2-D447-915B-97E8A25D1C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9C03269C-97EF-D043-B44A-DB55703999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AE91D3-742C-E048-8192-979A678C7DB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413648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D2DAA54C-7D92-2745-A183-DEC02FCF53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D4A3EB-807B-AC4C-BE36-2610353B9930}" type="datetimeFigureOut">
              <a:rPr kumimoji="1" lang="zh-CN" altLang="en-US" smtClean="0"/>
              <a:t>2020/1/16</a:t>
            </a:fld>
            <a:endParaRPr kumimoji="1"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A307FA58-67AA-B84E-9C68-AB9FFC4239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981FC138-6C62-0642-8C2D-D6E3AB5BB1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AE91D3-742C-E048-8192-979A678C7DB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0348029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7797707-AD06-9843-B2B2-6262F67D32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DC89AD2-47EC-124D-8CE4-619C56E2F18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3A6AD24-509A-264C-8EDD-EDBC2C200DF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10C0FF7-85CE-0845-ACF7-23FFA3FCAD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D4A3EB-807B-AC4C-BE36-2610353B9930}" type="datetimeFigureOut">
              <a:rPr kumimoji="1" lang="zh-CN" altLang="en-US" smtClean="0"/>
              <a:t>2020/1/16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1BE295D-C8F4-3B46-AEEF-5BDA26F535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E9D345D-2E81-BF4A-B6EC-876F43BA7B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AE91D3-742C-E048-8192-979A678C7DB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8925588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5D5CBA3-F5EA-CE48-BE09-713E472853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A2FA430A-9128-2D4B-9C92-87C98B9C9A5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6C60A8F-208A-A246-B185-C21FDFCDB5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8115F87-A94E-6C48-B4A2-43D0DC0849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D4A3EB-807B-AC4C-BE36-2610353B9930}" type="datetimeFigureOut">
              <a:rPr kumimoji="1" lang="zh-CN" altLang="en-US" smtClean="0"/>
              <a:t>2020/1/16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BE43FEC-517E-D24A-868F-072DA68D1C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8EEC440-5F4E-9F48-A807-5643389C71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AE91D3-742C-E048-8192-979A678C7DB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0739131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8E866B81-D017-2642-8B87-1CAF64CEB5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C2F5BE0-CCD9-B545-9716-E5BB386214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E2E8F8E-E481-074E-8762-06A3B2B1886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D4A3EB-807B-AC4C-BE36-2610353B9930}" type="datetimeFigureOut">
              <a:rPr kumimoji="1" lang="zh-CN" altLang="en-US" smtClean="0"/>
              <a:t>2020/1/16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960403E-510A-D246-9CED-4D1754A6D25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570FE16-A245-C94F-8974-CE248693947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AE91D3-742C-E048-8192-979A678C7DB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0625051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57A719A-571F-8C4D-B217-7856162534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zh-CN" dirty="0"/>
              <a:t>Key </a:t>
            </a:r>
            <a:r>
              <a:rPr kumimoji="1" lang="en-US" altLang="zh-CN"/>
              <a:t>summary points</a:t>
            </a:r>
            <a:endParaRPr kumimoji="1" lang="zh-CN" alt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5A806C4-A61F-E34B-AFCF-F6E766C4E4F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altLang="zh-CN" dirty="0"/>
              <a:t>this </a:t>
            </a:r>
            <a:r>
              <a:rPr lang="en-US" altLang="zh-CN" i="1" dirty="0"/>
              <a:t>in situ</a:t>
            </a:r>
            <a:r>
              <a:rPr lang="en-US" altLang="zh-CN" dirty="0"/>
              <a:t> study has demonstrated the potential of the vinegar rinsing approach for inhibition of biofilm formation in the </a:t>
            </a:r>
            <a:r>
              <a:rPr lang="en-US" altLang="zh-CN"/>
              <a:t>oral cavity.</a:t>
            </a:r>
            <a:endParaRPr lang="en-US" altLang="zh-CN" dirty="0"/>
          </a:p>
          <a:p>
            <a:r>
              <a:rPr lang="en-US" altLang="zh-CN" dirty="0"/>
              <a:t>It as well as has demonstrated strong removal effect towards the outer globular particles of the initial pellicle on the enamel surface.</a:t>
            </a:r>
            <a:endParaRPr lang="zh-CN" altLang="zh-CN" dirty="0"/>
          </a:p>
          <a:p>
            <a:endParaRPr kumimoji="1"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4010742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49</Words>
  <Application>Microsoft Macintosh PowerPoint</Application>
  <PresentationFormat>宽屏</PresentationFormat>
  <Paragraphs>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Key summary points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Key summary points</dc:title>
  <dc:creator>闻思婉 Siwan Wen</dc:creator>
  <cp:lastModifiedBy>Microsoft Office User</cp:lastModifiedBy>
  <cp:revision>3</cp:revision>
  <dcterms:created xsi:type="dcterms:W3CDTF">2019-11-12T00:53:14Z</dcterms:created>
  <dcterms:modified xsi:type="dcterms:W3CDTF">2020-01-16T08:02:29Z</dcterms:modified>
</cp:coreProperties>
</file>